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D6863-DA0C-4AD8-802F-57C675A55B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35469-E86E-4FAF-A787-54A39693BA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A3720-AF1B-466B-B10A-B867765B93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C6A77-1632-4840-9D91-241DCDE0A6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07C23-43F0-4A86-9625-3CECF6149A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39E3C-8E5F-437D-876F-CC2D4E0D72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67805-D38A-4DD1-B77A-5827EB49ED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601D1-00A6-47DF-BD9C-580CA87587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72AA7-AD7F-4E9E-8A7B-B6010DAFAA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04B36-8EC1-4FD7-B458-12F906DE6E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2B586-3C34-49CA-B76B-769B1F9209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94B69-AFA2-41C3-A2F8-4D25133276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223928-A341-4217-9C61-BC80DC5FF1F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1905120" y="380880"/>
            <a:ext cx="281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data Figure S1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Picture 2200"/>
          <p:cNvPicPr/>
          <p:nvPr/>
        </p:nvPicPr>
        <p:blipFill>
          <a:blip r:embed="rId1"/>
          <a:stretch/>
        </p:blipFill>
        <p:spPr>
          <a:xfrm rot="5400000">
            <a:off x="2640240" y="-1193040"/>
            <a:ext cx="1347840" cy="5410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Picture 2202"/>
          <p:cNvPicPr/>
          <p:nvPr/>
        </p:nvPicPr>
        <p:blipFill>
          <a:blip r:embed="rId2"/>
          <a:stretch/>
        </p:blipFill>
        <p:spPr>
          <a:xfrm rot="5400000">
            <a:off x="2598120" y="220320"/>
            <a:ext cx="1432080" cy="5410440"/>
          </a:xfrm>
          <a:prstGeom prst="rect">
            <a:avLst/>
          </a:prstGeom>
          <a:ln w="0">
            <a:noFill/>
          </a:ln>
        </p:spPr>
      </p:pic>
      <p:sp>
        <p:nvSpPr>
          <p:cNvPr id="44" name="Text Box 3"/>
          <p:cNvSpPr/>
          <p:nvPr/>
        </p:nvSpPr>
        <p:spPr>
          <a:xfrm>
            <a:off x="304920" y="228600"/>
            <a:ext cx="9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3" descr="Picture 2210"/>
          <p:cNvPicPr/>
          <p:nvPr/>
        </p:nvPicPr>
        <p:blipFill>
          <a:blip r:embed="rId3"/>
          <a:stretch/>
        </p:blipFill>
        <p:spPr>
          <a:xfrm>
            <a:off x="533520" y="3581280"/>
            <a:ext cx="5486400" cy="1582920"/>
          </a:xfrm>
          <a:prstGeom prst="rect">
            <a:avLst/>
          </a:prstGeom>
          <a:ln w="0">
            <a:noFill/>
          </a:ln>
        </p:spPr>
      </p:pic>
      <p:sp>
        <p:nvSpPr>
          <p:cNvPr id="46" name="AutoShape 14"/>
          <p:cNvSpPr/>
          <p:nvPr/>
        </p:nvSpPr>
        <p:spPr>
          <a:xfrm>
            <a:off x="533520" y="838080"/>
            <a:ext cx="5486400" cy="1371600"/>
          </a:xfrm>
          <a:prstGeom prst="flowChartProcess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15"/>
          <p:cNvSpPr/>
          <p:nvPr/>
        </p:nvSpPr>
        <p:spPr>
          <a:xfrm>
            <a:off x="533520" y="2209680"/>
            <a:ext cx="5486400" cy="1371600"/>
          </a:xfrm>
          <a:prstGeom prst="flowChartProcess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16"/>
          <p:cNvSpPr/>
          <p:nvPr/>
        </p:nvSpPr>
        <p:spPr>
          <a:xfrm>
            <a:off x="533520" y="4605480"/>
            <a:ext cx="5486400" cy="644400"/>
          </a:xfrm>
          <a:prstGeom prst="flowChartProcess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17"/>
          <p:cNvSpPr/>
          <p:nvPr/>
        </p:nvSpPr>
        <p:spPr>
          <a:xfrm>
            <a:off x="533520" y="3598920"/>
            <a:ext cx="5486400" cy="998640"/>
          </a:xfrm>
          <a:prstGeom prst="flowChartProcess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itle 1"/>
          <p:cNvSpPr/>
          <p:nvPr/>
        </p:nvSpPr>
        <p:spPr>
          <a:xfrm>
            <a:off x="152280" y="4495680"/>
            <a:ext cx="5716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itle 1"/>
          <p:cNvSpPr/>
          <p:nvPr/>
        </p:nvSpPr>
        <p:spPr>
          <a:xfrm>
            <a:off x="152280" y="2133720"/>
            <a:ext cx="5716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itle 1"/>
          <p:cNvSpPr/>
          <p:nvPr/>
        </p:nvSpPr>
        <p:spPr>
          <a:xfrm>
            <a:off x="152280" y="3505320"/>
            <a:ext cx="5716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itle 1"/>
          <p:cNvSpPr/>
          <p:nvPr/>
        </p:nvSpPr>
        <p:spPr>
          <a:xfrm>
            <a:off x="152280" y="762120"/>
            <a:ext cx="5716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"/>
          <p:cNvSpPr/>
          <p:nvPr/>
        </p:nvSpPr>
        <p:spPr>
          <a:xfrm>
            <a:off x="380880" y="5410080"/>
            <a:ext cx="5943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: Homology between human 14q32 miRNAs and CFA 8:72.3 Mb miRNAs locu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ata was obtained from entrez gene database (April 15 2012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-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nservation at the gene level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C-D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nservation at the miRNA level.  While the order is highly maintained only certain miRNAs are shown.  The position of miR-379 was used to orient the orthologous canine region of the genome to the human 14q32 loc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7T21:25:47Z</dcterms:created>
  <dc:creator>Aaron Sarver</dc:creator>
  <dc:description/>
  <dc:language>en-US</dc:language>
  <cp:lastModifiedBy>Subree Subramanian</cp:lastModifiedBy>
  <dcterms:modified xsi:type="dcterms:W3CDTF">2012-09-10T17:30:06Z</dcterms:modified>
  <cp:revision>17</cp:revision>
  <dc:subject/>
  <dc:title>PowerPoint Presentation</dc:title>
</cp:coreProperties>
</file>